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147377314" r:id="rId2"/>
    <p:sldId id="2147377307" r:id="rId3"/>
    <p:sldId id="2147377315" r:id="rId4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B98810F-D8E9-6E86-64AC-E5CBBD7512DE}" name="Yiru Zhu" initials="YZ" userId="S::yzv7997@ads.northwestern.edu::17dc072b-1c1f-4ec2-9681-b9eddcc440b0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E79"/>
    <a:srgbClr val="4D298E"/>
    <a:srgbClr val="3B57B0"/>
    <a:srgbClr val="8C9BFE"/>
    <a:srgbClr val="D46377"/>
    <a:srgbClr val="86BEFF"/>
    <a:srgbClr val="F3880E"/>
    <a:srgbClr val="C59EFC"/>
    <a:srgbClr val="AF9FC9"/>
    <a:srgbClr val="3A217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883"/>
    <p:restoredTop sz="96271"/>
  </p:normalViewPr>
  <p:slideViewPr>
    <p:cSldViewPr snapToGrid="0">
      <p:cViewPr>
        <p:scale>
          <a:sx n="70" d="100"/>
          <a:sy n="70" d="100"/>
        </p:scale>
        <p:origin x="2904" y="6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8/10/relationships/authors" Target="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C011CF-244C-3A4B-BF99-83CFF382DF08}" type="datetimeFigureOut">
              <a:rPr lang="en-US" smtClean="0"/>
              <a:t>10/13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56656E-CACA-2B4F-AECF-38AA1F5396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3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0FA6827-29C7-9CA9-0F78-90B1F020F6C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B00E8C77-5417-E959-1F7F-7916C9DC690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C42E960B-BF42-3762-C626-8D783A6BF5AC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>
              <a:latin typeface="Calibri"/>
              <a:ea typeface="Calibri"/>
              <a:cs typeface="Calibri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B302F0F-F35A-56CA-FD99-CA8451757CC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A56656E-CACA-2B4F-AECF-38AA1F53963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00825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>
              <a:latin typeface="Calibri"/>
              <a:ea typeface="Calibri"/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A56656E-CACA-2B4F-AECF-38AA1F53963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582276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3048554-3671-45E4-D3EF-02651A68357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AADE11C5-785F-C065-BEAB-56B7C447403A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6FAEB3C8-801A-6076-0427-DBC1C8F927CF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>
              <a:latin typeface="Calibri"/>
              <a:ea typeface="Calibri"/>
              <a:cs typeface="Calibri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8CAFC04-65CA-EF3E-BF43-B7E8157F3724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A56656E-CACA-2B4F-AECF-38AA1F53963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4193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71550" y="1646133"/>
            <a:ext cx="5829300" cy="3501813"/>
          </a:xfrm>
        </p:spPr>
        <p:txBody>
          <a:bodyPr anchor="b"/>
          <a:lstStyle>
            <a:lvl1pPr algn="ctr">
              <a:defRPr sz="382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1530"/>
            </a:lvl1pPr>
            <a:lvl2pPr marL="291465" indent="0" algn="ctr">
              <a:buNone/>
              <a:defRPr sz="1275"/>
            </a:lvl2pPr>
            <a:lvl3pPr marL="582930" indent="0" algn="ctr">
              <a:buNone/>
              <a:defRPr sz="1148"/>
            </a:lvl3pPr>
            <a:lvl4pPr marL="874395" indent="0" algn="ctr">
              <a:buNone/>
              <a:defRPr sz="1020"/>
            </a:lvl4pPr>
            <a:lvl5pPr marL="1165860" indent="0" algn="ctr">
              <a:buNone/>
              <a:defRPr sz="1020"/>
            </a:lvl5pPr>
            <a:lvl6pPr marL="1457325" indent="0" algn="ctr">
              <a:buNone/>
              <a:defRPr sz="1020"/>
            </a:lvl6pPr>
            <a:lvl7pPr marL="1748790" indent="0" algn="ctr">
              <a:buNone/>
              <a:defRPr sz="1020"/>
            </a:lvl7pPr>
            <a:lvl8pPr marL="2040255" indent="0" algn="ctr">
              <a:buNone/>
              <a:defRPr sz="1020"/>
            </a:lvl8pPr>
            <a:lvl9pPr marL="2331720" indent="0" algn="ctr">
              <a:buNone/>
              <a:defRPr sz="102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1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1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1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1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4" y="2507617"/>
            <a:ext cx="6703695" cy="4184014"/>
          </a:xfrm>
        </p:spPr>
        <p:txBody>
          <a:bodyPr anchor="b"/>
          <a:lstStyle>
            <a:lvl1pPr>
              <a:defRPr sz="382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4" y="6731213"/>
            <a:ext cx="6703695" cy="2200274"/>
          </a:xfrm>
        </p:spPr>
        <p:txBody>
          <a:bodyPr/>
          <a:lstStyle>
            <a:lvl1pPr marL="0" indent="0">
              <a:buNone/>
              <a:defRPr sz="1530">
                <a:solidFill>
                  <a:schemeClr val="tx1">
                    <a:tint val="82000"/>
                  </a:schemeClr>
                </a:solidFill>
              </a:defRPr>
            </a:lvl1pPr>
            <a:lvl2pPr marL="291465" indent="0">
              <a:buNone/>
              <a:defRPr sz="1275">
                <a:solidFill>
                  <a:schemeClr val="tx1">
                    <a:tint val="82000"/>
                  </a:schemeClr>
                </a:solidFill>
              </a:defRPr>
            </a:lvl2pPr>
            <a:lvl3pPr marL="582930" indent="0">
              <a:buNone/>
              <a:defRPr sz="1148">
                <a:solidFill>
                  <a:schemeClr val="tx1">
                    <a:tint val="82000"/>
                  </a:schemeClr>
                </a:solidFill>
              </a:defRPr>
            </a:lvl3pPr>
            <a:lvl4pPr marL="874395" indent="0">
              <a:buNone/>
              <a:defRPr sz="1020">
                <a:solidFill>
                  <a:schemeClr val="tx1">
                    <a:tint val="82000"/>
                  </a:schemeClr>
                </a:solidFill>
              </a:defRPr>
            </a:lvl4pPr>
            <a:lvl5pPr marL="1165860" indent="0">
              <a:buNone/>
              <a:defRPr sz="1020">
                <a:solidFill>
                  <a:schemeClr val="tx1">
                    <a:tint val="82000"/>
                  </a:schemeClr>
                </a:solidFill>
              </a:defRPr>
            </a:lvl5pPr>
            <a:lvl6pPr marL="1457325" indent="0">
              <a:buNone/>
              <a:defRPr sz="1020">
                <a:solidFill>
                  <a:schemeClr val="tx1">
                    <a:tint val="82000"/>
                  </a:schemeClr>
                </a:solidFill>
              </a:defRPr>
            </a:lvl6pPr>
            <a:lvl7pPr marL="1748790" indent="0">
              <a:buNone/>
              <a:defRPr sz="1020">
                <a:solidFill>
                  <a:schemeClr val="tx1">
                    <a:tint val="82000"/>
                  </a:schemeClr>
                </a:solidFill>
              </a:defRPr>
            </a:lvl7pPr>
            <a:lvl8pPr marL="2040255" indent="0">
              <a:buNone/>
              <a:defRPr sz="1020">
                <a:solidFill>
                  <a:schemeClr val="tx1">
                    <a:tint val="82000"/>
                  </a:schemeClr>
                </a:solidFill>
              </a:defRPr>
            </a:lvl8pPr>
            <a:lvl9pPr marL="2331720" indent="0">
              <a:buNone/>
              <a:defRPr sz="102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1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13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7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5" y="2465706"/>
            <a:ext cx="3288089" cy="1208404"/>
          </a:xfrm>
        </p:spPr>
        <p:txBody>
          <a:bodyPr anchor="b"/>
          <a:lstStyle>
            <a:lvl1pPr marL="0" indent="0">
              <a:buNone/>
              <a:defRPr sz="1530" b="1"/>
            </a:lvl1pPr>
            <a:lvl2pPr marL="291465" indent="0">
              <a:buNone/>
              <a:defRPr sz="1275" b="1"/>
            </a:lvl2pPr>
            <a:lvl3pPr marL="582930" indent="0">
              <a:buNone/>
              <a:defRPr sz="1148" b="1"/>
            </a:lvl3pPr>
            <a:lvl4pPr marL="874395" indent="0">
              <a:buNone/>
              <a:defRPr sz="1020" b="1"/>
            </a:lvl4pPr>
            <a:lvl5pPr marL="1165860" indent="0">
              <a:buNone/>
              <a:defRPr sz="1020" b="1"/>
            </a:lvl5pPr>
            <a:lvl6pPr marL="1457325" indent="0">
              <a:buNone/>
              <a:defRPr sz="1020" b="1"/>
            </a:lvl6pPr>
            <a:lvl7pPr marL="1748790" indent="0">
              <a:buNone/>
              <a:defRPr sz="1020" b="1"/>
            </a:lvl7pPr>
            <a:lvl8pPr marL="2040255" indent="0">
              <a:buNone/>
              <a:defRPr sz="1020" b="1"/>
            </a:lvl8pPr>
            <a:lvl9pPr marL="2331720" indent="0">
              <a:buNone/>
              <a:defRPr sz="10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5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1530" b="1"/>
            </a:lvl1pPr>
            <a:lvl2pPr marL="291465" indent="0">
              <a:buNone/>
              <a:defRPr sz="1275" b="1"/>
            </a:lvl2pPr>
            <a:lvl3pPr marL="582930" indent="0">
              <a:buNone/>
              <a:defRPr sz="1148" b="1"/>
            </a:lvl3pPr>
            <a:lvl4pPr marL="874395" indent="0">
              <a:buNone/>
              <a:defRPr sz="1020" b="1"/>
            </a:lvl4pPr>
            <a:lvl5pPr marL="1165860" indent="0">
              <a:buNone/>
              <a:defRPr sz="1020" b="1"/>
            </a:lvl5pPr>
            <a:lvl6pPr marL="1457325" indent="0">
              <a:buNone/>
              <a:defRPr sz="1020" b="1"/>
            </a:lvl6pPr>
            <a:lvl7pPr marL="1748790" indent="0">
              <a:buNone/>
              <a:defRPr sz="1020" b="1"/>
            </a:lvl7pPr>
            <a:lvl8pPr marL="2040255" indent="0">
              <a:buNone/>
              <a:defRPr sz="1020" b="1"/>
            </a:lvl8pPr>
            <a:lvl9pPr marL="2331720" indent="0">
              <a:buNone/>
              <a:defRPr sz="10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13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13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13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04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4"/>
            <a:ext cx="3934778" cy="7147983"/>
          </a:xfrm>
        </p:spPr>
        <p:txBody>
          <a:bodyPr/>
          <a:lstStyle>
            <a:lvl1pPr>
              <a:defRPr sz="2040"/>
            </a:lvl1pPr>
            <a:lvl2pPr>
              <a:defRPr sz="1785"/>
            </a:lvl2pPr>
            <a:lvl3pPr>
              <a:defRPr sz="1530"/>
            </a:lvl3pPr>
            <a:lvl4pPr>
              <a:defRPr sz="1275"/>
            </a:lvl4pPr>
            <a:lvl5pPr>
              <a:defRPr sz="1275"/>
            </a:lvl5pPr>
            <a:lvl6pPr>
              <a:defRPr sz="1275"/>
            </a:lvl6pPr>
            <a:lvl7pPr>
              <a:defRPr sz="1275"/>
            </a:lvl7pPr>
            <a:lvl8pPr>
              <a:defRPr sz="1275"/>
            </a:lvl8pPr>
            <a:lvl9pPr>
              <a:defRPr sz="127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020"/>
            </a:lvl1pPr>
            <a:lvl2pPr marL="291465" indent="0">
              <a:buNone/>
              <a:defRPr sz="893"/>
            </a:lvl2pPr>
            <a:lvl3pPr marL="582930" indent="0">
              <a:buNone/>
              <a:defRPr sz="765"/>
            </a:lvl3pPr>
            <a:lvl4pPr marL="874395" indent="0">
              <a:buNone/>
              <a:defRPr sz="638"/>
            </a:lvl4pPr>
            <a:lvl5pPr marL="1165860" indent="0">
              <a:buNone/>
              <a:defRPr sz="638"/>
            </a:lvl5pPr>
            <a:lvl6pPr marL="1457325" indent="0">
              <a:buNone/>
              <a:defRPr sz="638"/>
            </a:lvl6pPr>
            <a:lvl7pPr marL="1748790" indent="0">
              <a:buNone/>
              <a:defRPr sz="638"/>
            </a:lvl7pPr>
            <a:lvl8pPr marL="2040255" indent="0">
              <a:buNone/>
              <a:defRPr sz="638"/>
            </a:lvl8pPr>
            <a:lvl9pPr marL="2331720" indent="0">
              <a:buNone/>
              <a:defRPr sz="63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13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04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4"/>
            <a:ext cx="3934778" cy="7147983"/>
          </a:xfrm>
        </p:spPr>
        <p:txBody>
          <a:bodyPr anchor="t"/>
          <a:lstStyle>
            <a:lvl1pPr marL="0" indent="0">
              <a:buNone/>
              <a:defRPr sz="2040"/>
            </a:lvl1pPr>
            <a:lvl2pPr marL="291465" indent="0">
              <a:buNone/>
              <a:defRPr sz="1785"/>
            </a:lvl2pPr>
            <a:lvl3pPr marL="582930" indent="0">
              <a:buNone/>
              <a:defRPr sz="1530"/>
            </a:lvl3pPr>
            <a:lvl4pPr marL="874395" indent="0">
              <a:buNone/>
              <a:defRPr sz="1275"/>
            </a:lvl4pPr>
            <a:lvl5pPr marL="1165860" indent="0">
              <a:buNone/>
              <a:defRPr sz="1275"/>
            </a:lvl5pPr>
            <a:lvl6pPr marL="1457325" indent="0">
              <a:buNone/>
              <a:defRPr sz="1275"/>
            </a:lvl6pPr>
            <a:lvl7pPr marL="1748790" indent="0">
              <a:buNone/>
              <a:defRPr sz="1275"/>
            </a:lvl7pPr>
            <a:lvl8pPr marL="2040255" indent="0">
              <a:buNone/>
              <a:defRPr sz="1275"/>
            </a:lvl8pPr>
            <a:lvl9pPr marL="2331720" indent="0">
              <a:buNone/>
              <a:defRPr sz="1275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020"/>
            </a:lvl1pPr>
            <a:lvl2pPr marL="291465" indent="0">
              <a:buNone/>
              <a:defRPr sz="893"/>
            </a:lvl2pPr>
            <a:lvl3pPr marL="582930" indent="0">
              <a:buNone/>
              <a:defRPr sz="765"/>
            </a:lvl3pPr>
            <a:lvl4pPr marL="874395" indent="0">
              <a:buNone/>
              <a:defRPr sz="638"/>
            </a:lvl4pPr>
            <a:lvl5pPr marL="1165860" indent="0">
              <a:buNone/>
              <a:defRPr sz="638"/>
            </a:lvl5pPr>
            <a:lvl6pPr marL="1457325" indent="0">
              <a:buNone/>
              <a:defRPr sz="638"/>
            </a:lvl6pPr>
            <a:lvl7pPr marL="1748790" indent="0">
              <a:buNone/>
              <a:defRPr sz="638"/>
            </a:lvl7pPr>
            <a:lvl8pPr marL="2040255" indent="0">
              <a:buNone/>
              <a:defRPr sz="638"/>
            </a:lvl8pPr>
            <a:lvl9pPr marL="2331720" indent="0">
              <a:buNone/>
              <a:defRPr sz="63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13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7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7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6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10/1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7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6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7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6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emf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10" Type="http://schemas.openxmlformats.org/officeDocument/2006/relationships/image" Target="../media/image8.tiff"/><Relationship Id="rId4" Type="http://schemas.openxmlformats.org/officeDocument/2006/relationships/image" Target="../media/image2.jpeg"/><Relationship Id="rId9" Type="http://schemas.openxmlformats.org/officeDocument/2006/relationships/image" Target="../media/image7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13" Type="http://schemas.openxmlformats.org/officeDocument/2006/relationships/image" Target="../media/image19.emf"/><Relationship Id="rId3" Type="http://schemas.openxmlformats.org/officeDocument/2006/relationships/image" Target="../media/image9.jpeg"/><Relationship Id="rId7" Type="http://schemas.openxmlformats.org/officeDocument/2006/relationships/image" Target="../media/image13.png"/><Relationship Id="rId12" Type="http://schemas.openxmlformats.org/officeDocument/2006/relationships/image" Target="../media/image18.emf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22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11" Type="http://schemas.openxmlformats.org/officeDocument/2006/relationships/image" Target="../media/image17.emf"/><Relationship Id="rId5" Type="http://schemas.openxmlformats.org/officeDocument/2006/relationships/image" Target="../media/image11.png"/><Relationship Id="rId15" Type="http://schemas.openxmlformats.org/officeDocument/2006/relationships/image" Target="../media/image21.emf"/><Relationship Id="rId10" Type="http://schemas.openxmlformats.org/officeDocument/2006/relationships/image" Target="../media/image16.emf"/><Relationship Id="rId4" Type="http://schemas.openxmlformats.org/officeDocument/2006/relationships/image" Target="../media/image10.png"/><Relationship Id="rId9" Type="http://schemas.openxmlformats.org/officeDocument/2006/relationships/image" Target="../media/image15.png"/><Relationship Id="rId14" Type="http://schemas.openxmlformats.org/officeDocument/2006/relationships/image" Target="../media/image2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ECA14FB-1EA9-81BE-8161-C391954C1A8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5B5E96E-C24C-00A6-459B-B08953D9C883}"/>
              </a:ext>
            </a:extLst>
          </p:cNvPr>
          <p:cNvSpPr txBox="1">
            <a:spLocks noChangeAspect="1"/>
          </p:cNvSpPr>
          <p:nvPr/>
        </p:nvSpPr>
        <p:spPr>
          <a:xfrm>
            <a:off x="0" y="52552"/>
            <a:ext cx="44034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58D0DD56-8F27-23A3-35A0-30100861EAB1}"/>
              </a:ext>
            </a:extLst>
          </p:cNvPr>
          <p:cNvGrpSpPr>
            <a:grpSpLocks noChangeAspect="1"/>
          </p:cNvGrpSpPr>
          <p:nvPr/>
        </p:nvGrpSpPr>
        <p:grpSpPr>
          <a:xfrm>
            <a:off x="3276043" y="806472"/>
            <a:ext cx="4139801" cy="5911061"/>
            <a:chOff x="5422058" y="20906724"/>
            <a:chExt cx="6008374" cy="6052958"/>
          </a:xfrm>
        </p:grpSpPr>
        <p:grpSp>
          <p:nvGrpSpPr>
            <p:cNvPr id="1038" name="Group 1037">
              <a:extLst>
                <a:ext uri="{FF2B5EF4-FFF2-40B4-BE49-F238E27FC236}">
                  <a16:creationId xmlns:a16="http://schemas.microsoft.com/office/drawing/2014/main" id="{FCB45F6E-BABC-C4EA-E598-30303ED0A91B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422058" y="20906724"/>
              <a:ext cx="6008374" cy="6052958"/>
              <a:chOff x="856443" y="2004485"/>
              <a:chExt cx="3429000" cy="3222481"/>
            </a:xfrm>
          </p:grpSpPr>
          <p:sp>
            <p:nvSpPr>
              <p:cNvPr id="1046" name="Triangle 1045">
                <a:extLst>
                  <a:ext uri="{FF2B5EF4-FFF2-40B4-BE49-F238E27FC236}">
                    <a16:creationId xmlns:a16="http://schemas.microsoft.com/office/drawing/2014/main" id="{DCD7E5D7-DDA7-CC44-14A0-A75F12D7F76B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0800000">
                <a:off x="856443" y="2004485"/>
                <a:ext cx="3429000" cy="3202083"/>
              </a:xfrm>
              <a:prstGeom prst="triangle">
                <a:avLst/>
              </a:prstGeom>
              <a:solidFill>
                <a:srgbClr val="CBC2DB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47" name="Triangle 1046">
                <a:extLst>
                  <a:ext uri="{FF2B5EF4-FFF2-40B4-BE49-F238E27FC236}">
                    <a16:creationId xmlns:a16="http://schemas.microsoft.com/office/drawing/2014/main" id="{FB453E7E-3BE7-9563-B515-DA12B45E8037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0800000">
                <a:off x="1330278" y="2884871"/>
                <a:ext cx="2479116" cy="2321698"/>
              </a:xfrm>
              <a:prstGeom prst="triangle">
                <a:avLst/>
              </a:prstGeom>
              <a:solidFill>
                <a:srgbClr val="B1A0D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49" name="Triangle 1048">
                <a:extLst>
                  <a:ext uri="{FF2B5EF4-FFF2-40B4-BE49-F238E27FC236}">
                    <a16:creationId xmlns:a16="http://schemas.microsoft.com/office/drawing/2014/main" id="{8A501DD2-721C-5827-DDE6-FDE17D203E57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0800000">
                <a:off x="1804115" y="3773857"/>
                <a:ext cx="1530544" cy="1453109"/>
              </a:xfrm>
              <a:prstGeom prst="triangle">
                <a:avLst>
                  <a:gd name="adj" fmla="val 49201"/>
                </a:avLst>
              </a:prstGeom>
              <a:solidFill>
                <a:srgbClr val="9278C2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039" name="TextBox 1038">
              <a:extLst>
                <a:ext uri="{FF2B5EF4-FFF2-40B4-BE49-F238E27FC236}">
                  <a16:creationId xmlns:a16="http://schemas.microsoft.com/office/drawing/2014/main" id="{39059EBE-5D6A-9C8E-6316-7A1D3203350C}"/>
                </a:ext>
              </a:extLst>
            </p:cNvPr>
            <p:cNvSpPr txBox="1"/>
            <p:nvPr/>
          </p:nvSpPr>
          <p:spPr>
            <a:xfrm>
              <a:off x="6437074" y="21195838"/>
              <a:ext cx="3972880" cy="110307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600" b="1">
                  <a:latin typeface="Arial" panose="020B0604020202020204" pitchFamily="34" charset="0"/>
                  <a:cs typeface="Arial" panose="020B0604020202020204" pitchFamily="34" charset="0"/>
                </a:rPr>
                <a:t>Selleckchem Bioactive </a:t>
              </a:r>
              <a:br>
                <a:rPr lang="en-US" sz="1600" b="1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1600" b="1">
                  <a:latin typeface="Arial" panose="020B0604020202020204" pitchFamily="34" charset="0"/>
                  <a:cs typeface="Arial" panose="020B0604020202020204" pitchFamily="34" charset="0"/>
                </a:rPr>
                <a:t>Compound Library II</a:t>
              </a:r>
            </a:p>
            <a:p>
              <a:pPr algn="ctr"/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Catalog No. L1700-II</a:t>
              </a:r>
            </a:p>
            <a:p>
              <a:pPr algn="ctr"/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(n=5309)</a:t>
              </a:r>
            </a:p>
          </p:txBody>
        </p:sp>
        <p:sp>
          <p:nvSpPr>
            <p:cNvPr id="1040" name="TextBox 1039">
              <a:extLst>
                <a:ext uri="{FF2B5EF4-FFF2-40B4-BE49-F238E27FC236}">
                  <a16:creationId xmlns:a16="http://schemas.microsoft.com/office/drawing/2014/main" id="{C1026FF9-B743-6FCE-9CF5-8CE10495BA94}"/>
                </a:ext>
              </a:extLst>
            </p:cNvPr>
            <p:cNvSpPr txBox="1"/>
            <p:nvPr/>
          </p:nvSpPr>
          <p:spPr>
            <a:xfrm>
              <a:off x="6735142" y="22969843"/>
              <a:ext cx="3376749" cy="850945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600" b="1">
                  <a:latin typeface="Arial" panose="020B0604020202020204" pitchFamily="34" charset="0"/>
                  <a:cs typeface="Arial" panose="020B0604020202020204" pitchFamily="34" charset="0"/>
                </a:rPr>
                <a:t>High-priority</a:t>
              </a:r>
              <a:br>
                <a:rPr lang="en-US" sz="1600" b="1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1600" b="1">
                  <a:latin typeface="Arial" panose="020B0604020202020204" pitchFamily="34" charset="0"/>
                  <a:cs typeface="Arial" panose="020B0604020202020204" pitchFamily="34" charset="0"/>
                </a:rPr>
                <a:t>compounds</a:t>
              </a:r>
              <a:endParaRPr 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(n=2812)</a:t>
              </a:r>
            </a:p>
          </p:txBody>
        </p:sp>
        <p:sp>
          <p:nvSpPr>
            <p:cNvPr id="1045" name="TextBox 1044">
              <a:extLst>
                <a:ext uri="{FF2B5EF4-FFF2-40B4-BE49-F238E27FC236}">
                  <a16:creationId xmlns:a16="http://schemas.microsoft.com/office/drawing/2014/main" id="{A59549EF-4CA6-5B34-5777-343BCCA5FE1A}"/>
                </a:ext>
              </a:extLst>
            </p:cNvPr>
            <p:cNvSpPr txBox="1"/>
            <p:nvPr/>
          </p:nvSpPr>
          <p:spPr>
            <a:xfrm>
              <a:off x="7396033" y="24520133"/>
              <a:ext cx="2054964" cy="850945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6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lected </a:t>
              </a:r>
            </a:p>
            <a:p>
              <a:pPr algn="ctr"/>
              <a:r>
                <a:rPr lang="en-US" sz="16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pounds</a:t>
              </a:r>
            </a:p>
            <a:p>
              <a:pPr algn="ctr"/>
              <a:r>
                <a:rPr lang="en-US" sz="160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=818)</a:t>
              </a:r>
            </a:p>
          </p:txBody>
        </p:sp>
      </p:grpSp>
      <p:grpSp>
        <p:nvGrpSpPr>
          <p:cNvPr id="1050" name="Group 1049">
            <a:extLst>
              <a:ext uri="{FF2B5EF4-FFF2-40B4-BE49-F238E27FC236}">
                <a16:creationId xmlns:a16="http://schemas.microsoft.com/office/drawing/2014/main" id="{CFBC6F9D-A3DA-21E2-A1DB-AB2110A3471C}"/>
              </a:ext>
            </a:extLst>
          </p:cNvPr>
          <p:cNvGrpSpPr/>
          <p:nvPr/>
        </p:nvGrpSpPr>
        <p:grpSpPr>
          <a:xfrm>
            <a:off x="426061" y="2417683"/>
            <a:ext cx="3667469" cy="1401200"/>
            <a:chOff x="673789" y="2286784"/>
            <a:chExt cx="7936517" cy="1401200"/>
          </a:xfrm>
        </p:grpSpPr>
        <p:cxnSp>
          <p:nvCxnSpPr>
            <p:cNvPr id="1051" name="Straight Connector 1050">
              <a:extLst>
                <a:ext uri="{FF2B5EF4-FFF2-40B4-BE49-F238E27FC236}">
                  <a16:creationId xmlns:a16="http://schemas.microsoft.com/office/drawing/2014/main" id="{B70DFCF8-31E4-8499-1F31-01814B06B8D1}"/>
                </a:ext>
              </a:extLst>
            </p:cNvPr>
            <p:cNvCxnSpPr>
              <a:cxnSpLocks noChangeAspect="1"/>
            </p:cNvCxnSpPr>
            <p:nvPr/>
          </p:nvCxnSpPr>
          <p:spPr>
            <a:xfrm flipH="1">
              <a:off x="862180" y="2286784"/>
              <a:ext cx="6880146" cy="0"/>
            </a:xfrm>
            <a:prstGeom prst="line">
              <a:avLst/>
            </a:prstGeom>
            <a:ln w="38100"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52" name="TextBox 1051">
              <a:extLst>
                <a:ext uri="{FF2B5EF4-FFF2-40B4-BE49-F238E27FC236}">
                  <a16:creationId xmlns:a16="http://schemas.microsoft.com/office/drawing/2014/main" id="{E0889A05-296D-E99B-0103-FF760CB5E7F9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673789" y="2518433"/>
              <a:ext cx="7936517" cy="1169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>
                  <a:latin typeface="Arial" panose="020B0604020202020204" pitchFamily="34" charset="0"/>
                  <a:cs typeface="Arial" panose="020B0604020202020204" pitchFamily="34" charset="0"/>
                </a:rPr>
                <a:t>Filtering out compounds with undesirable qualities:</a:t>
              </a:r>
            </a:p>
            <a:p>
              <a:pPr marL="342900" indent="-342900">
                <a:buFont typeface="Arial" panose="020B0604020202020204" pitchFamily="34" charset="0"/>
                <a:buChar char="•"/>
              </a:pPr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Pan-assay interference (PAINS), unprogressable chemical features, predicted poor solubility &amp; permeability</a:t>
              </a:r>
            </a:p>
          </p:txBody>
        </p:sp>
      </p:grpSp>
      <p:grpSp>
        <p:nvGrpSpPr>
          <p:cNvPr id="1053" name="Group 1052">
            <a:extLst>
              <a:ext uri="{FF2B5EF4-FFF2-40B4-BE49-F238E27FC236}">
                <a16:creationId xmlns:a16="http://schemas.microsoft.com/office/drawing/2014/main" id="{C0D5DBF0-DC89-394A-02F0-B784DF14C5E1}"/>
              </a:ext>
            </a:extLst>
          </p:cNvPr>
          <p:cNvGrpSpPr/>
          <p:nvPr/>
        </p:nvGrpSpPr>
        <p:grpSpPr>
          <a:xfrm>
            <a:off x="429634" y="4052066"/>
            <a:ext cx="3973835" cy="2586893"/>
            <a:chOff x="4593376" y="3008513"/>
            <a:chExt cx="3973835" cy="2586893"/>
          </a:xfrm>
        </p:grpSpPr>
        <p:cxnSp>
          <p:nvCxnSpPr>
            <p:cNvPr id="1054" name="Straight Connector 1053">
              <a:extLst>
                <a:ext uri="{FF2B5EF4-FFF2-40B4-BE49-F238E27FC236}">
                  <a16:creationId xmlns:a16="http://schemas.microsoft.com/office/drawing/2014/main" id="{6357AE2F-BF8E-4A85-81FE-6FFEBAF076EA}"/>
                </a:ext>
              </a:extLst>
            </p:cNvPr>
            <p:cNvCxnSpPr>
              <a:cxnSpLocks noChangeAspect="1"/>
            </p:cNvCxnSpPr>
            <p:nvPr/>
          </p:nvCxnSpPr>
          <p:spPr>
            <a:xfrm flipH="1">
              <a:off x="4676859" y="3008513"/>
              <a:ext cx="3808903" cy="0"/>
            </a:xfrm>
            <a:prstGeom prst="line">
              <a:avLst/>
            </a:prstGeom>
            <a:ln w="38100"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55" name="TextBox 1054">
              <a:extLst>
                <a:ext uri="{FF2B5EF4-FFF2-40B4-BE49-F238E27FC236}">
                  <a16:creationId xmlns:a16="http://schemas.microsoft.com/office/drawing/2014/main" id="{B2A01A7E-E4B4-FF27-AB07-766387316937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593376" y="3348637"/>
              <a:ext cx="3973835" cy="22467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>
                  <a:latin typeface="Arial" panose="020B0604020202020204" pitchFamily="34" charset="0"/>
                  <a:cs typeface="Arial" panose="020B0604020202020204" pitchFamily="34" charset="0"/>
                </a:rPr>
                <a:t>Filtering out compounds with </a:t>
              </a:r>
              <a:br>
                <a:rPr lang="en-US" sz="1400" b="1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1400" b="1">
                  <a:latin typeface="Arial" panose="020B0604020202020204" pitchFamily="34" charset="0"/>
                  <a:cs typeface="Arial" panose="020B0604020202020204" pitchFamily="34" charset="0"/>
                </a:rPr>
                <a:t>undesirable targets:</a:t>
              </a:r>
            </a:p>
            <a:p>
              <a:pPr marL="342900" indent="-342900">
                <a:buFont typeface="Arial" panose="020B0604020202020204" pitchFamily="34" charset="0"/>
                <a:buChar char="•"/>
              </a:pPr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Compounds annotated to bind to sex hormone (androgen, estrogen) receptor or affect sex hormone production</a:t>
              </a:r>
            </a:p>
            <a:p>
              <a:r>
                <a:rPr lang="en-US" sz="1400" b="1">
                  <a:latin typeface="Arial" panose="020B0604020202020204" pitchFamily="34" charset="0"/>
                  <a:cs typeface="Arial" panose="020B0604020202020204" pitchFamily="34" charset="0"/>
                </a:rPr>
                <a:t>Prioritized the following features: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Strong potency and few total targets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Diverse set of annotated targets (n=207)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Diverse set of chemical structures (n=505)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Compound analogs and others (n=106)</a:t>
              </a:r>
            </a:p>
          </p:txBody>
        </p:sp>
      </p:grpSp>
      <p:sp>
        <p:nvSpPr>
          <p:cNvPr id="1056" name="TextBox 1055">
            <a:extLst>
              <a:ext uri="{FF2B5EF4-FFF2-40B4-BE49-F238E27FC236}">
                <a16:creationId xmlns:a16="http://schemas.microsoft.com/office/drawing/2014/main" id="{47CD6D12-24D1-CC25-53C0-908F2FDDFA83}"/>
              </a:ext>
            </a:extLst>
          </p:cNvPr>
          <p:cNvSpPr txBox="1">
            <a:spLocks noChangeAspect="1"/>
          </p:cNvSpPr>
          <p:nvPr/>
        </p:nvSpPr>
        <p:spPr>
          <a:xfrm>
            <a:off x="426061" y="1363416"/>
            <a:ext cx="305355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Compound library composition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Structurally diverse, medicinally active, and cell permeable</a:t>
            </a:r>
          </a:p>
        </p:txBody>
      </p:sp>
    </p:spTree>
    <p:extLst>
      <p:ext uri="{BB962C8B-B14F-4D97-AF65-F5344CB8AC3E}">
        <p14:creationId xmlns:p14="http://schemas.microsoft.com/office/powerpoint/2010/main" val="23682326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2722129-5123-EE6C-F349-2113F586CCD3}"/>
              </a:ext>
            </a:extLst>
          </p:cNvPr>
          <p:cNvSpPr txBox="1">
            <a:spLocks noChangeAspect="1"/>
          </p:cNvSpPr>
          <p:nvPr/>
        </p:nvSpPr>
        <p:spPr>
          <a:xfrm>
            <a:off x="58430" y="5983"/>
            <a:ext cx="44034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010FA3B1-426D-EA4C-0ACA-2697F0A3C33E}"/>
              </a:ext>
            </a:extLst>
          </p:cNvPr>
          <p:cNvSpPr txBox="1"/>
          <p:nvPr/>
        </p:nvSpPr>
        <p:spPr>
          <a:xfrm>
            <a:off x="132725" y="503139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7A2D07D-430A-97D5-E0FD-65FB317FBE5E}"/>
              </a:ext>
            </a:extLst>
          </p:cNvPr>
          <p:cNvSpPr txBox="1"/>
          <p:nvPr/>
        </p:nvSpPr>
        <p:spPr>
          <a:xfrm>
            <a:off x="132725" y="4233098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76E62940-A0FF-6CDE-3D58-CAD3F4EDFA5A}"/>
              </a:ext>
            </a:extLst>
          </p:cNvPr>
          <p:cNvGrpSpPr/>
          <p:nvPr/>
        </p:nvGrpSpPr>
        <p:grpSpPr>
          <a:xfrm>
            <a:off x="972760" y="4233098"/>
            <a:ext cx="6323390" cy="3068311"/>
            <a:chOff x="972760" y="4233098"/>
            <a:chExt cx="6323390" cy="3068311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91E77B95-75BD-C370-B68B-5D588D09D99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/>
            <a:stretch/>
          </p:blipFill>
          <p:spPr>
            <a:xfrm>
              <a:off x="972760" y="4233098"/>
              <a:ext cx="6323390" cy="3068311"/>
            </a:xfrm>
            <a:prstGeom prst="rect">
              <a:avLst/>
            </a:prstGeom>
          </p:spPr>
        </p:pic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D6006593-1195-9E97-13F2-74B8CF0A43CF}"/>
                </a:ext>
              </a:extLst>
            </p:cNvPr>
            <p:cNvSpPr/>
            <p:nvPr/>
          </p:nvSpPr>
          <p:spPr>
            <a:xfrm>
              <a:off x="6721642" y="4633208"/>
              <a:ext cx="256674" cy="1874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66A2D2F7-76B6-0324-3F5F-9D590D5C403D}"/>
              </a:ext>
            </a:extLst>
          </p:cNvPr>
          <p:cNvGrpSpPr/>
          <p:nvPr/>
        </p:nvGrpSpPr>
        <p:grpSpPr>
          <a:xfrm>
            <a:off x="1143000" y="517698"/>
            <a:ext cx="5486400" cy="3237162"/>
            <a:chOff x="1143000" y="517698"/>
            <a:chExt cx="5486400" cy="3237162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A8E264AA-738B-E2F8-A083-149C059C6DC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143000" y="517698"/>
              <a:ext cx="5486400" cy="3237162"/>
              <a:chOff x="640864" y="580337"/>
              <a:chExt cx="4009759" cy="2365893"/>
            </a:xfrm>
          </p:grpSpPr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0CA605AE-5E88-725D-19E3-B314DE51A50C}"/>
                  </a:ext>
                </a:extLst>
              </p:cNvPr>
              <p:cNvSpPr txBox="1"/>
              <p:nvPr/>
            </p:nvSpPr>
            <p:spPr>
              <a:xfrm>
                <a:off x="640864" y="580337"/>
                <a:ext cx="915278" cy="224940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sz="1400">
                    <a:latin typeface="Arial" panose="020B0604020202020204" pitchFamily="34" charset="0"/>
                    <a:cs typeface="Arial" panose="020B0604020202020204" pitchFamily="34" charset="0"/>
                  </a:rPr>
                  <a:t>DMSO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5542CDF5-5B1E-BBB9-4B62-DE7A2A7BE36C}"/>
                  </a:ext>
                </a:extLst>
              </p:cNvPr>
              <p:cNvSpPr txBox="1"/>
              <p:nvPr/>
            </p:nvSpPr>
            <p:spPr>
              <a:xfrm>
                <a:off x="1477857" y="583643"/>
                <a:ext cx="1238384" cy="224940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sz="1400">
                    <a:latin typeface="Arial" panose="020B0604020202020204" pitchFamily="34" charset="0"/>
                    <a:cs typeface="Arial" panose="020B0604020202020204" pitchFamily="34" charset="0"/>
                  </a:rPr>
                  <a:t>Cycloheximide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72646A69-0C8B-420E-7314-63937D16A625}"/>
                  </a:ext>
                </a:extLst>
              </p:cNvPr>
              <p:cNvSpPr txBox="1"/>
              <p:nvPr/>
            </p:nvSpPr>
            <p:spPr>
              <a:xfrm>
                <a:off x="2426681" y="591096"/>
                <a:ext cx="1238384" cy="224940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sz="1400">
                    <a:latin typeface="Arial" panose="020B0604020202020204" pitchFamily="34" charset="0"/>
                    <a:cs typeface="Arial" panose="020B0604020202020204" pitchFamily="34" charset="0"/>
                  </a:rPr>
                  <a:t>Digitonin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2FEC3D3B-477F-8624-D349-47C07A61F6BD}"/>
                  </a:ext>
                </a:extLst>
              </p:cNvPr>
              <p:cNvSpPr txBox="1"/>
              <p:nvPr/>
            </p:nvSpPr>
            <p:spPr>
              <a:xfrm>
                <a:off x="3405154" y="580338"/>
                <a:ext cx="1238384" cy="224940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sz="1400">
                    <a:latin typeface="Arial" panose="020B0604020202020204" pitchFamily="34" charset="0"/>
                    <a:cs typeface="Arial" panose="020B0604020202020204" pitchFamily="34" charset="0"/>
                  </a:rPr>
                  <a:t>BVT-948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8236E03B-A4CD-D46B-51D0-808C20678594}"/>
                  </a:ext>
                </a:extLst>
              </p:cNvPr>
              <p:cNvSpPr txBox="1"/>
              <p:nvPr/>
            </p:nvSpPr>
            <p:spPr>
              <a:xfrm>
                <a:off x="1452739" y="1806248"/>
                <a:ext cx="1238384" cy="224940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sz="1400">
                    <a:latin typeface="Arial" panose="020B0604020202020204" pitchFamily="34" charset="0"/>
                    <a:cs typeface="Arial" panose="020B0604020202020204" pitchFamily="34" charset="0"/>
                  </a:rPr>
                  <a:t>NSC-663284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462BBA27-164A-ABEA-2715-12DC18C276DE}"/>
                  </a:ext>
                </a:extLst>
              </p:cNvPr>
              <p:cNvSpPr txBox="1"/>
              <p:nvPr/>
            </p:nvSpPr>
            <p:spPr>
              <a:xfrm>
                <a:off x="2428360" y="1806245"/>
                <a:ext cx="1238384" cy="224940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sz="1400">
                    <a:latin typeface="Arial" panose="020B0604020202020204" pitchFamily="34" charset="0"/>
                    <a:cs typeface="Arial" panose="020B0604020202020204" pitchFamily="34" charset="0"/>
                  </a:rPr>
                  <a:t>Rottlerin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1F5EB099-7285-66E4-DD16-01159243C967}"/>
                  </a:ext>
                </a:extLst>
              </p:cNvPr>
              <p:cNvSpPr txBox="1"/>
              <p:nvPr/>
            </p:nvSpPr>
            <p:spPr>
              <a:xfrm>
                <a:off x="3412239" y="1805539"/>
                <a:ext cx="1238384" cy="224940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sz="1400">
                    <a:latin typeface="Arial" panose="020B0604020202020204" pitchFamily="34" charset="0"/>
                    <a:cs typeface="Arial" panose="020B0604020202020204" pitchFamily="34" charset="0"/>
                  </a:rPr>
                  <a:t>Doxorubicin</a:t>
                </a:r>
              </a:p>
            </p:txBody>
          </p:sp>
          <p:pic>
            <p:nvPicPr>
              <p:cNvPr id="1026" name="Picture 2" descr="A picture containing screenshot, circle, fog&#10;&#10;Description automatically generated">
                <a:extLst>
                  <a:ext uri="{FF2B5EF4-FFF2-40B4-BE49-F238E27FC236}">
                    <a16:creationId xmlns:a16="http://schemas.microsoft.com/office/drawing/2014/main" id="{671256D3-B9AC-E1CC-87A5-A4F535F69646}"/>
                  </a:ext>
                </a:extLst>
              </p:cNvPr>
              <p:cNvPicPr>
                <a:picLocks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2161" t="38203" r="39480" b="35701"/>
              <a:stretch/>
            </p:blipFill>
            <p:spPr bwMode="auto">
              <a:xfrm>
                <a:off x="1644377" y="815917"/>
                <a:ext cx="846474" cy="89318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28" name="Picture 4" descr="A picture containing drawing, sketch, mold, art&#10;&#10;Description automatically generated">
                <a:extLst>
                  <a:ext uri="{FF2B5EF4-FFF2-40B4-BE49-F238E27FC236}">
                    <a16:creationId xmlns:a16="http://schemas.microsoft.com/office/drawing/2014/main" id="{044E89AE-D939-5D1F-0BF4-BF4A944ABFD2}"/>
                  </a:ext>
                </a:extLst>
              </p:cNvPr>
              <p:cNvPicPr>
                <a:picLocks noChangeArrowheads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500" t="45447" r="56447" b="31114"/>
              <a:stretch/>
            </p:blipFill>
            <p:spPr bwMode="auto">
              <a:xfrm>
                <a:off x="2624127" y="815917"/>
                <a:ext cx="846474" cy="893185"/>
              </a:xfrm>
              <a:prstGeom prst="rect">
                <a:avLst/>
              </a:prstGeom>
              <a:noFill/>
              <a:ln w="19050">
                <a:solidFill>
                  <a:schemeClr val="tx1">
                    <a:lumMod val="95000"/>
                    <a:lumOff val="5000"/>
                  </a:schemeClr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30" name="Picture 6" descr="A picture containing circle, bathroom&#10;&#10;Description automatically generated">
                <a:extLst>
                  <a:ext uri="{FF2B5EF4-FFF2-40B4-BE49-F238E27FC236}">
                    <a16:creationId xmlns:a16="http://schemas.microsoft.com/office/drawing/2014/main" id="{AEA23A59-4C9B-C9EF-B236-1A685D810D0D}"/>
                  </a:ext>
                </a:extLst>
              </p:cNvPr>
              <p:cNvPicPr>
                <a:picLocks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4538" t="35097" r="36823" b="41482"/>
              <a:stretch/>
            </p:blipFill>
            <p:spPr bwMode="auto">
              <a:xfrm>
                <a:off x="3603877" y="815917"/>
                <a:ext cx="846474" cy="89318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32" name="Picture 8" descr="A picture containing circle, black and white&#10;&#10;Description automatically generated">
                <a:extLst>
                  <a:ext uri="{FF2B5EF4-FFF2-40B4-BE49-F238E27FC236}">
                    <a16:creationId xmlns:a16="http://schemas.microsoft.com/office/drawing/2014/main" id="{B341114D-9D3D-DCAD-B123-9781DEE542FC}"/>
                  </a:ext>
                </a:extLst>
              </p:cNvPr>
              <p:cNvPicPr>
                <a:picLocks noChangeArrowheads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440" t="48164" r="41328" b="27864"/>
              <a:stretch/>
            </p:blipFill>
            <p:spPr bwMode="auto">
              <a:xfrm>
                <a:off x="1655925" y="2053045"/>
                <a:ext cx="846474" cy="89318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34" name="Picture 10" descr="A picture containing mold&#10;&#10;Description automatically generated with medium confidence">
                <a:extLst>
                  <a:ext uri="{FF2B5EF4-FFF2-40B4-BE49-F238E27FC236}">
                    <a16:creationId xmlns:a16="http://schemas.microsoft.com/office/drawing/2014/main" id="{00CCAEBE-B779-7E6F-0C8C-DD0915B8E5F1}"/>
                  </a:ext>
                </a:extLst>
              </p:cNvPr>
              <p:cNvPicPr>
                <a:picLocks noChangeArrowheads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696" t="26819" r="45642" b="49399"/>
              <a:stretch/>
            </p:blipFill>
            <p:spPr bwMode="auto">
              <a:xfrm>
                <a:off x="2635675" y="2053044"/>
                <a:ext cx="846474" cy="89318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36" name="Picture 12" descr="A picture containing circle, fog&#10;&#10;Description automatically generated">
                <a:extLst>
                  <a:ext uri="{FF2B5EF4-FFF2-40B4-BE49-F238E27FC236}">
                    <a16:creationId xmlns:a16="http://schemas.microsoft.com/office/drawing/2014/main" id="{34980FC9-7FAB-F87B-A7A4-E9A951B56304}"/>
                  </a:ext>
                </a:extLst>
              </p:cNvPr>
              <p:cNvPicPr>
                <a:picLocks noChangeArrowheads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3479" t="48778" r="28295" b="27822"/>
              <a:stretch/>
            </p:blipFill>
            <p:spPr bwMode="auto">
              <a:xfrm>
                <a:off x="3615425" y="2053043"/>
                <a:ext cx="846474" cy="89318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6" name="Picture 35" descr="A group of round objects&#10;&#10;Description automatically generated">
                <a:extLst>
                  <a:ext uri="{FF2B5EF4-FFF2-40B4-BE49-F238E27FC236}">
                    <a16:creationId xmlns:a16="http://schemas.microsoft.com/office/drawing/2014/main" id="{8938E21B-2ADA-B049-AE40-3BBA20109FDC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461" t="47775" r="43185" b="28586"/>
              <a:stretch/>
            </p:blipFill>
            <p:spPr>
              <a:xfrm>
                <a:off x="662650" y="816812"/>
                <a:ext cx="846474" cy="893185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</p:grpSp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5AC4D36E-7939-A846-4BFE-79CD937DB8E2}"/>
                </a:ext>
              </a:extLst>
            </p:cNvPr>
            <p:cNvCxnSpPr>
              <a:cxnSpLocks/>
            </p:cNvCxnSpPr>
            <p:nvPr/>
          </p:nvCxnSpPr>
          <p:spPr>
            <a:xfrm>
              <a:off x="1962150" y="1041400"/>
              <a:ext cx="48478" cy="155158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CC76A650-6D62-76EE-B142-DE405EC8618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14783" y="1950081"/>
              <a:ext cx="136460" cy="8603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116AA0BC-CBBA-D23C-4A92-987D043A84B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852691" y="1419623"/>
              <a:ext cx="71359" cy="145652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821677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17D1848-16A1-C881-8709-259083C9541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8D4D7C4-F433-5169-013C-0D1AC871396E}"/>
              </a:ext>
            </a:extLst>
          </p:cNvPr>
          <p:cNvSpPr txBox="1">
            <a:spLocks noChangeAspect="1"/>
          </p:cNvSpPr>
          <p:nvPr/>
        </p:nvSpPr>
        <p:spPr>
          <a:xfrm>
            <a:off x="58430" y="5983"/>
            <a:ext cx="44034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</a:p>
        </p:txBody>
      </p:sp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B1504D00-524E-88FA-1A82-0EC25E5E8AF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7022035"/>
              </p:ext>
            </p:extLst>
          </p:nvPr>
        </p:nvGraphicFramePr>
        <p:xfrm>
          <a:off x="323271" y="759125"/>
          <a:ext cx="7125861" cy="501047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171974">
                  <a:extLst>
                    <a:ext uri="{9D8B030D-6E8A-4147-A177-3AD203B41FA5}">
                      <a16:colId xmlns:a16="http://schemas.microsoft.com/office/drawing/2014/main" val="961003657"/>
                    </a:ext>
                  </a:extLst>
                </a:gridCol>
                <a:gridCol w="1529751">
                  <a:extLst>
                    <a:ext uri="{9D8B030D-6E8A-4147-A177-3AD203B41FA5}">
                      <a16:colId xmlns:a16="http://schemas.microsoft.com/office/drawing/2014/main" val="1139555990"/>
                    </a:ext>
                  </a:extLst>
                </a:gridCol>
                <a:gridCol w="2284941">
                  <a:extLst>
                    <a:ext uri="{9D8B030D-6E8A-4147-A177-3AD203B41FA5}">
                      <a16:colId xmlns:a16="http://schemas.microsoft.com/office/drawing/2014/main" val="3574241255"/>
                    </a:ext>
                  </a:extLst>
                </a:gridCol>
                <a:gridCol w="713065">
                  <a:extLst>
                    <a:ext uri="{9D8B030D-6E8A-4147-A177-3AD203B41FA5}">
                      <a16:colId xmlns:a16="http://schemas.microsoft.com/office/drawing/2014/main" val="3598372196"/>
                    </a:ext>
                  </a:extLst>
                </a:gridCol>
                <a:gridCol w="713065">
                  <a:extLst>
                    <a:ext uri="{9D8B030D-6E8A-4147-A177-3AD203B41FA5}">
                      <a16:colId xmlns:a16="http://schemas.microsoft.com/office/drawing/2014/main" val="2132918266"/>
                    </a:ext>
                  </a:extLst>
                </a:gridCol>
                <a:gridCol w="713065">
                  <a:extLst>
                    <a:ext uri="{9D8B030D-6E8A-4147-A177-3AD203B41FA5}">
                      <a16:colId xmlns:a16="http://schemas.microsoft.com/office/drawing/2014/main" val="2156122945"/>
                    </a:ext>
                  </a:extLst>
                </a:gridCol>
              </a:tblGrid>
              <a:tr h="49536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ound </a:t>
                      </a:r>
                      <a:r>
                        <a:rPr lang="en-US" sz="1200" b="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0 µM)</a:t>
                      </a: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379" marR="5637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emical </a:t>
                      </a:r>
                      <a:b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ucture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379" marR="5637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ationale</a:t>
                      </a:r>
                    </a:p>
                  </a:txBody>
                  <a:tcPr marL="56379" marR="5637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V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379" marR="5637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VBD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379" marR="5637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I</a:t>
                      </a:r>
                      <a:endParaRPr lang="en-US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379" marR="5637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4163039"/>
                  </a:ext>
                </a:extLst>
              </a:tr>
              <a:tr h="645016"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lrinone</a:t>
                      </a:r>
                      <a:r>
                        <a:rPr lang="en-US" sz="1200" b="0" i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​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379" marR="5637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ve control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​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​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​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7260870"/>
                  </a:ext>
                </a:extLst>
              </a:tr>
              <a:tr h="64501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AY-296993 </a:t>
                      </a:r>
                      <a:r>
                        <a:rPr lang="en-US" sz="1200" b="0" i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​</a:t>
                      </a:r>
                      <a:endParaRPr kumimoji="0" lang="en-US" sz="12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379" marR="5637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t compound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​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​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​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3218153"/>
                  </a:ext>
                </a:extLst>
              </a:tr>
              <a:tr h="645016"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NX-211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379" marR="5637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 I clinical trial </a:t>
                      </a:r>
                      <a:b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solid tumors)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​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​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5457035"/>
                  </a:ext>
                </a:extLst>
              </a:tr>
              <a:tr h="6450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-DMAG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379" marR="5637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 I clinical trial </a:t>
                      </a:r>
                      <a:b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solid tumors)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​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​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%​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67158669"/>
                  </a:ext>
                </a:extLst>
              </a:tr>
              <a:tr h="6450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netespib</a:t>
                      </a:r>
                      <a:endParaRPr lang="en-US" sz="1200" b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379" marR="5637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 II clinical trial </a:t>
                      </a:r>
                      <a:b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lung cancer)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%​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%​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%​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4565675"/>
                  </a:ext>
                </a:extLst>
              </a:tr>
              <a:tr h="6450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alespib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1" marR="95251" marT="95247" marB="95247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379" marR="5637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 II clinical trial </a:t>
                      </a:r>
                      <a:b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solid tumors)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%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%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%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8919410"/>
                  </a:ext>
                </a:extLst>
              </a:tr>
              <a:tr h="6450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mitespib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2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6379" marR="5637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ically approved (solid tumor gastrointestinal cancer)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%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%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1200" b="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%</a:t>
                      </a:r>
                    </a:p>
                  </a:txBody>
                  <a:tcPr marL="77073" marR="77073" marT="38535" marB="3853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50358435"/>
                  </a:ext>
                </a:extLst>
              </a:tr>
            </a:tbl>
          </a:graphicData>
        </a:graphic>
      </p:graphicFrame>
      <p:pic>
        <p:nvPicPr>
          <p:cNvPr id="17" name="Picture 3" descr="A structure of a chemical formula&#10;&#10;Description automatically generated">
            <a:extLst>
              <a:ext uri="{FF2B5EF4-FFF2-40B4-BE49-F238E27FC236}">
                <a16:creationId xmlns:a16="http://schemas.microsoft.com/office/drawing/2014/main" id="{2960FC6D-2372-06A4-7C44-733A70E2343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10546" y="1294529"/>
            <a:ext cx="860772" cy="569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17" descr="A structure of a chemical formula&#10;&#10;Description automatically generated">
            <a:extLst>
              <a:ext uri="{FF2B5EF4-FFF2-40B4-BE49-F238E27FC236}">
                <a16:creationId xmlns:a16="http://schemas.microsoft.com/office/drawing/2014/main" id="{BFF0E748-BB49-488D-1689-3EA1A483420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7493" b="15818"/>
          <a:stretch/>
        </p:blipFill>
        <p:spPr>
          <a:xfrm rot="10800000">
            <a:off x="1678255" y="1920031"/>
            <a:ext cx="1125354" cy="569055"/>
          </a:xfrm>
          <a:prstGeom prst="rect">
            <a:avLst/>
          </a:prstGeom>
        </p:spPr>
      </p:pic>
      <p:pic>
        <p:nvPicPr>
          <p:cNvPr id="20" name="Picture 19" descr="A structure of a chemical formula&#10;&#10;AI-generated content may be incorrect.">
            <a:extLst>
              <a:ext uri="{FF2B5EF4-FFF2-40B4-BE49-F238E27FC236}">
                <a16:creationId xmlns:a16="http://schemas.microsoft.com/office/drawing/2014/main" id="{F9F732CA-E1AA-EB0A-8362-35AC597F4B9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7078" y="2558891"/>
            <a:ext cx="648949" cy="589746"/>
          </a:xfrm>
          <a:prstGeom prst="rect">
            <a:avLst/>
          </a:prstGeom>
        </p:spPr>
      </p:pic>
      <p:pic>
        <p:nvPicPr>
          <p:cNvPr id="22" name="Picture 21" descr="A diagram of a molecule&#10;&#10;AI-generated content may be incorrect.">
            <a:extLst>
              <a:ext uri="{FF2B5EF4-FFF2-40B4-BE49-F238E27FC236}">
                <a16:creationId xmlns:a16="http://schemas.microsoft.com/office/drawing/2014/main" id="{2D746674-AFB2-6014-0DC0-E19FCE5412E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6361" y="3199763"/>
            <a:ext cx="938067" cy="621110"/>
          </a:xfrm>
          <a:prstGeom prst="rect">
            <a:avLst/>
          </a:prstGeom>
        </p:spPr>
      </p:pic>
      <p:pic>
        <p:nvPicPr>
          <p:cNvPr id="24" name="Picture 23" descr="A diagram of a molecule&#10;&#10;AI-generated content may be incorrect.">
            <a:extLst>
              <a:ext uri="{FF2B5EF4-FFF2-40B4-BE49-F238E27FC236}">
                <a16:creationId xmlns:a16="http://schemas.microsoft.com/office/drawing/2014/main" id="{5DA02FC1-BB15-8C24-6CA6-19C90BC8A77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3518" y="3853563"/>
            <a:ext cx="694825" cy="596235"/>
          </a:xfrm>
          <a:prstGeom prst="rect">
            <a:avLst/>
          </a:prstGeom>
        </p:spPr>
      </p:pic>
      <p:pic>
        <p:nvPicPr>
          <p:cNvPr id="26" name="Picture 25" descr="A structure of a molecule&#10;&#10;AI-generated content may be incorrect.">
            <a:extLst>
              <a:ext uri="{FF2B5EF4-FFF2-40B4-BE49-F238E27FC236}">
                <a16:creationId xmlns:a16="http://schemas.microsoft.com/office/drawing/2014/main" id="{A97B76F9-A86C-743D-ABC6-B709980B47F8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9086" y="4498027"/>
            <a:ext cx="1292615" cy="581468"/>
          </a:xfrm>
          <a:prstGeom prst="rect">
            <a:avLst/>
          </a:prstGeom>
        </p:spPr>
      </p:pic>
      <p:pic>
        <p:nvPicPr>
          <p:cNvPr id="28" name="Picture 27" descr="A molecule of a substance&#10;&#10;AI-generated content may be incorrect.">
            <a:extLst>
              <a:ext uri="{FF2B5EF4-FFF2-40B4-BE49-F238E27FC236}">
                <a16:creationId xmlns:a16="http://schemas.microsoft.com/office/drawing/2014/main" id="{71E88AE8-7595-EC4F-6ABF-662FD79CE0E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0274" y="5138641"/>
            <a:ext cx="1210238" cy="590857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78EDC0DB-4F31-0237-5916-210218CF8B91}"/>
              </a:ext>
            </a:extLst>
          </p:cNvPr>
          <p:cNvSpPr txBox="1"/>
          <p:nvPr/>
        </p:nvSpPr>
        <p:spPr>
          <a:xfrm>
            <a:off x="132725" y="375315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77057F6-A69E-3781-95D4-A582B283C2D0}"/>
              </a:ext>
            </a:extLst>
          </p:cNvPr>
          <p:cNvSpPr txBox="1"/>
          <p:nvPr/>
        </p:nvSpPr>
        <p:spPr>
          <a:xfrm>
            <a:off x="132725" y="5947713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635E5353-261B-1E1B-5E97-65C519EAAD11}"/>
              </a:ext>
            </a:extLst>
          </p:cNvPr>
          <p:cNvGrpSpPr/>
          <p:nvPr/>
        </p:nvGrpSpPr>
        <p:grpSpPr>
          <a:xfrm>
            <a:off x="1513722" y="5989343"/>
            <a:ext cx="5247402" cy="3878835"/>
            <a:chOff x="1513722" y="5989343"/>
            <a:chExt cx="5247402" cy="3878835"/>
          </a:xfrm>
        </p:grpSpPr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0904C180-5C3F-7574-94F3-E66AE20970C1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rcRect l="-37" t="-884" r="41283" b="884"/>
            <a:stretch/>
          </p:blipFill>
          <p:spPr>
            <a:xfrm>
              <a:off x="1513722" y="5989343"/>
              <a:ext cx="1353473" cy="1963012"/>
            </a:xfrm>
            <a:prstGeom prst="rect">
              <a:avLst/>
            </a:prstGeom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46C99C02-F70E-4CAC-A699-036AECCAA5EA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rcRect t="-1767" r="41016" b="1767"/>
            <a:stretch/>
          </p:blipFill>
          <p:spPr>
            <a:xfrm>
              <a:off x="2988244" y="5989343"/>
              <a:ext cx="1352606" cy="1872176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3777DD6C-202A-3FE3-5E7A-4B232F7599E2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rcRect r="39476"/>
            <a:stretch/>
          </p:blipFill>
          <p:spPr>
            <a:xfrm>
              <a:off x="4461899" y="6018576"/>
              <a:ext cx="1371600" cy="1842943"/>
            </a:xfrm>
            <a:prstGeom prst="rect">
              <a:avLst/>
            </a:prstGeom>
          </p:spPr>
        </p:pic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3E3C971F-2B6A-667D-ED7E-57E5461720AE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rcRect l="357" t="1913" r="43273" b="-1913"/>
            <a:stretch/>
          </p:blipFill>
          <p:spPr>
            <a:xfrm>
              <a:off x="2996800" y="7969712"/>
              <a:ext cx="1352865" cy="1898466"/>
            </a:xfrm>
            <a:prstGeom prst="rect">
              <a:avLst/>
            </a:prstGeom>
          </p:spPr>
        </p:pic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AD48BCD2-B9BD-2577-79B2-0B212CF95704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rcRect l="-1983" t="-1416" r="44085" b="1416"/>
            <a:stretch/>
          </p:blipFill>
          <p:spPr>
            <a:xfrm>
              <a:off x="1514589" y="7937652"/>
              <a:ext cx="1352606" cy="1889946"/>
            </a:xfrm>
            <a:prstGeom prst="rect">
              <a:avLst/>
            </a:prstGeom>
          </p:spPr>
        </p:pic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40A28D83-5919-F1CC-014D-0214A0BC6CA2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rcRect l="-1024" t="1424" r="40299" b="-1424"/>
            <a:stretch/>
          </p:blipFill>
          <p:spPr>
            <a:xfrm>
              <a:off x="4461899" y="7979278"/>
              <a:ext cx="1371600" cy="1879333"/>
            </a:xfrm>
            <a:prstGeom prst="rect">
              <a:avLst/>
            </a:prstGeom>
          </p:spPr>
        </p:pic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0724BFC4-52CE-24EC-0D2D-B595C04B6B0F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rcRect l="66063" t="419" r="-305" b="55581"/>
            <a:stretch/>
          </p:blipFill>
          <p:spPr>
            <a:xfrm>
              <a:off x="5954548" y="6021309"/>
              <a:ext cx="806576" cy="835315"/>
            </a:xfrm>
            <a:prstGeom prst="rect">
              <a:avLst/>
            </a:prstGeom>
          </p:spPr>
        </p:pic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82CB809D-68FC-A96A-2CE8-2B30D99E8CAE}"/>
                </a:ext>
              </a:extLst>
            </p:cNvPr>
            <p:cNvSpPr/>
            <p:nvPr/>
          </p:nvSpPr>
          <p:spPr>
            <a:xfrm>
              <a:off x="6472366" y="6321180"/>
              <a:ext cx="256674" cy="1874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11170724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 panose="020B000402020202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7d76d361-8277-4708-a477-64e8366cd1bc}" enabled="0" method="" siteId="{7d76d361-8277-4708-a477-64e8366cd1bc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96</TotalTime>
  <Words>262</Words>
  <Application>Microsoft Macintosh PowerPoint</Application>
  <PresentationFormat>Custom</PresentationFormat>
  <Paragraphs>77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Jeffrey Tsung Pea</cp:lastModifiedBy>
  <cp:revision>3</cp:revision>
  <dcterms:created xsi:type="dcterms:W3CDTF">2024-07-24T20:43:25Z</dcterms:created>
  <dcterms:modified xsi:type="dcterms:W3CDTF">2025-10-15T14:51:19Z</dcterms:modified>
</cp:coreProperties>
</file>